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4EFCE1-9F55-4334-9FAB-872ED94D5772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4A88C8-1A0A-4ED1-A77B-D178B8690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2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822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66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084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690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69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9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2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0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76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36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F0553-8230-45C5-B503-7ED6E25E4620}" type="datetimeFigureOut">
              <a:rPr lang="en-US" smtClean="0"/>
              <a:t>6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C3BBC-1CA7-4703-ADCB-5C0F6CBBE2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321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0075" y="1917118"/>
            <a:ext cx="4260456" cy="32004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76650" y="2652001"/>
            <a:ext cx="1796720" cy="173736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232302" y="5059975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076496" y="5059975"/>
            <a:ext cx="8851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veh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97484" y="5059975"/>
            <a:ext cx="10005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shNC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215093" y="5059975"/>
            <a:ext cx="10028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MCAO+shLPA</a:t>
            </a:r>
            <a:r>
              <a:rPr lang="en-US" altLang="ko-KR" sz="1000" baseline="-25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2589974" y="2301264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Iba1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2579394" y="3355126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BrdU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2504854" y="4427707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Overla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835819" y="4272574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518050" y="4508350"/>
            <a:ext cx="679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8523785" y="4266676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8315295" y="4506268"/>
            <a:ext cx="10058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8880699" y="4266676"/>
            <a:ext cx="6319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LPA</a:t>
            </a:r>
            <a:r>
              <a:rPr lang="en-US" altLang="ko-KR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263440" y="4272574"/>
            <a:ext cx="3898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6625772" y="3420926"/>
            <a:ext cx="18036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No. of 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rdU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/Iba1</a:t>
            </a:r>
            <a:r>
              <a:rPr lang="en-US" altLang="ko-KR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cells/mm</a:t>
            </a:r>
            <a:r>
              <a: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636268" y="15690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135264" y="15690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541376" y="2760960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2" name="TextBox 20"/>
          <p:cNvSpPr txBox="1"/>
          <p:nvPr/>
        </p:nvSpPr>
        <p:spPr>
          <a:xfrm>
            <a:off x="8996636" y="286757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+mj-lt"/>
                <a:cs typeface="Arial" panose="020B0604020202020204" pitchFamily="34" charset="0"/>
              </a:rPr>
              <a:t>#</a:t>
            </a:r>
            <a:endParaRPr lang="en-US" sz="1200" dirty="0">
              <a:latin typeface="+mj-lt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202076" y="2801222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smtClean="0">
                <a:latin typeface="+mj-lt"/>
                <a:cs typeface="Arial" panose="020B0604020202020204" pitchFamily="34" charset="0"/>
              </a:rPr>
              <a:t>***</a:t>
            </a:r>
            <a:endParaRPr lang="en-US" sz="1600" dirty="0">
              <a:latin typeface="+mj-lt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1007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4</TotalTime>
  <Words>24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사용자</dc:creator>
  <cp:lastModifiedBy>Windows 사용자</cp:lastModifiedBy>
  <cp:revision>90</cp:revision>
  <dcterms:created xsi:type="dcterms:W3CDTF">2019-06-25T05:43:47Z</dcterms:created>
  <dcterms:modified xsi:type="dcterms:W3CDTF">2019-06-30T03:10:14Z</dcterms:modified>
</cp:coreProperties>
</file>